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handoutMasterIdLst>
    <p:handoutMasterId r:id="rId7"/>
  </p:handoutMasterIdLst>
  <p:sldIdLst>
    <p:sldId id="299" r:id="rId2"/>
    <p:sldId id="258" r:id="rId3"/>
    <p:sldId id="296" r:id="rId4"/>
    <p:sldId id="284" r:id="rId5"/>
  </p:sldIdLst>
  <p:sldSz cx="6858000" cy="9906000" type="A4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9F0EB9-835C-7371-49BC-0150A905D01E}" name="Sharesta Khoenkhoen" initials="SK" userId="S::sharesta.khoenkhoen@t-knife.com::da2c6783-19f9-457f-8227-7a08e355fcb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000"/>
    <a:srgbClr val="0000FF"/>
    <a:srgbClr val="0066FF"/>
    <a:srgbClr val="000000"/>
    <a:srgbClr val="1C1C1C"/>
    <a:srgbClr val="292929"/>
    <a:srgbClr val="111111"/>
    <a:srgbClr val="8CFF61"/>
    <a:srgbClr val="8DF173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2" autoAdjust="0"/>
    <p:restoredTop sz="88485" autoAdjust="0"/>
  </p:normalViewPr>
  <p:slideViewPr>
    <p:cSldViewPr snapToGrid="0">
      <p:cViewPr>
        <p:scale>
          <a:sx n="90" d="100"/>
          <a:sy n="90" d="100"/>
        </p:scale>
        <p:origin x="1292" y="-25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nika Àdori" userId="d8fe2df5-8b6d-4356-a439-7c7a43006dc5" providerId="ADAL" clId="{BBE2BC52-94B9-49EC-AFED-B9C2A85A2610}"/>
    <pc:docChg chg="modSld">
      <pc:chgData name="Monika Àdori" userId="d8fe2df5-8b6d-4356-a439-7c7a43006dc5" providerId="ADAL" clId="{BBE2BC52-94B9-49EC-AFED-B9C2A85A2610}" dt="2022-10-10T06:06:51.202" v="22" actId="20577"/>
      <pc:docMkLst>
        <pc:docMk/>
      </pc:docMkLst>
      <pc:sldChg chg="modSp mod">
        <pc:chgData name="Monika Àdori" userId="d8fe2df5-8b6d-4356-a439-7c7a43006dc5" providerId="ADAL" clId="{BBE2BC52-94B9-49EC-AFED-B9C2A85A2610}" dt="2022-10-10T06:06:51.202" v="22" actId="20577"/>
        <pc:sldMkLst>
          <pc:docMk/>
          <pc:sldMk cId="241141105" sldId="299"/>
        </pc:sldMkLst>
        <pc:spChg chg="mod">
          <ac:chgData name="Monika Àdori" userId="d8fe2df5-8b6d-4356-a439-7c7a43006dc5" providerId="ADAL" clId="{BBE2BC52-94B9-49EC-AFED-B9C2A85A2610}" dt="2022-10-10T06:06:51.202" v="22" actId="20577"/>
          <ac:spMkLst>
            <pc:docMk/>
            <pc:sldMk cId="241141105" sldId="299"/>
            <ac:spMk id="73" creationId="{6C5A59DC-BF6F-EE35-598A-3111093AAB5A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D00FC5A-686C-AC9B-BE4A-D522D387BD1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8BA0C5C-EF8A-A87E-9CFA-2F91F6884AA9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43628F-DEE5-48D0-A607-F54F27C7E80F}" type="datetimeFigureOut">
              <a:rPr lang="sv-SE" smtClean="0"/>
              <a:t>2022-10-10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640454-9FE6-3280-7372-09C84A147AD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11F2C3-032F-353A-BBD2-A6F52CB20D2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CD30E-1EFC-4C9F-B881-014D7C68EA0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83382123"/>
      </p:ext>
    </p:extLst>
  </p:cSld>
  <p:clrMap bg1="lt1" tx1="dk1" bg2="lt2" tx2="dk2" accent1="accent1" accent2="accent2" accent3="accent3" accent4="accent4" accent5="accent5" accent6="accent6" hlink="hlink" folHlink="folHlink"/>
  <p:hf sldNum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B273D-5B70-4000-ACAD-7BC2085CFCCE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963"/>
            <a:ext cx="543560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4DC83-A20C-455D-9C0B-E29BE1463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0567275"/>
      </p:ext>
    </p:extLst>
  </p:cSld>
  <p:clrMap bg1="lt1" tx1="dk1" bg2="lt2" tx2="dk2" accent1="accent1" accent2="accent2" accent3="accent3" accent4="accent4" accent5="accent5" accent6="accent6" hlink="hlink" folHlink="folHlink"/>
  <p:hf sldNum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D87B0752-BD7A-B91E-98F3-7378733F9414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7028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F05A3EBF-851F-EB6F-3E99-9D5F2633B9FF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52506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6E4E1CB5-FA73-EE25-62EE-439E5AB99D12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4010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0E200FFB-DE67-AEEC-2E12-AACE30A7233C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588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77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152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580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6555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369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194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09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1274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2059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6709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665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81383-91E5-443A-8FC3-7F76FEB51111}" type="datetimeFigureOut">
              <a:rPr lang="en-GB" smtClean="0"/>
              <a:t>1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13B5B-450C-4C0F-A83E-1FBBB28FF4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582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4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7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oleObject" Target="../embeddings/oleObject2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5" Type="http://schemas.openxmlformats.org/officeDocument/2006/relationships/image" Target="../media/image12.png"/><Relationship Id="rId23" Type="http://schemas.openxmlformats.org/officeDocument/2006/relationships/image" Target="../media/image19.jpeg"/><Relationship Id="rId10" Type="http://schemas.openxmlformats.org/officeDocument/2006/relationships/image" Target="../media/image7.png"/><Relationship Id="rId19" Type="http://schemas.openxmlformats.org/officeDocument/2006/relationships/image" Target="../media/image15.png"/><Relationship Id="rId4" Type="http://schemas.openxmlformats.org/officeDocument/2006/relationships/image" Target="../media/image1.emf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27.emf"/><Relationship Id="rId26" Type="http://schemas.openxmlformats.org/officeDocument/2006/relationships/image" Target="../media/image33.png"/><Relationship Id="rId3" Type="http://schemas.openxmlformats.org/officeDocument/2006/relationships/oleObject" Target="../embeddings/oleObject3.bin"/><Relationship Id="rId21" Type="http://schemas.openxmlformats.org/officeDocument/2006/relationships/oleObject" Target="../embeddings/oleObject12.bin"/><Relationship Id="rId34" Type="http://schemas.openxmlformats.org/officeDocument/2006/relationships/image" Target="../media/image38.emf"/><Relationship Id="rId7" Type="http://schemas.openxmlformats.org/officeDocument/2006/relationships/oleObject" Target="../embeddings/oleObject5.bin"/><Relationship Id="rId12" Type="http://schemas.openxmlformats.org/officeDocument/2006/relationships/image" Target="../media/image24.emf"/><Relationship Id="rId17" Type="http://schemas.openxmlformats.org/officeDocument/2006/relationships/oleObject" Target="../embeddings/oleObject10.bin"/><Relationship Id="rId25" Type="http://schemas.openxmlformats.org/officeDocument/2006/relationships/image" Target="../media/image32.png"/><Relationship Id="rId33" Type="http://schemas.openxmlformats.org/officeDocument/2006/relationships/oleObject" Target="../embeddings/oleObject15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6.emf"/><Relationship Id="rId20" Type="http://schemas.openxmlformats.org/officeDocument/2006/relationships/image" Target="../media/image28.emf"/><Relationship Id="rId29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emf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31.png"/><Relationship Id="rId32" Type="http://schemas.openxmlformats.org/officeDocument/2006/relationships/image" Target="../media/image37.png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23" Type="http://schemas.openxmlformats.org/officeDocument/2006/relationships/image" Target="../media/image30.png"/><Relationship Id="rId28" Type="http://schemas.openxmlformats.org/officeDocument/2006/relationships/image" Target="../media/image34.emf"/><Relationship Id="rId10" Type="http://schemas.openxmlformats.org/officeDocument/2006/relationships/image" Target="../media/image23.emf"/><Relationship Id="rId19" Type="http://schemas.openxmlformats.org/officeDocument/2006/relationships/oleObject" Target="../embeddings/oleObject11.bin"/><Relationship Id="rId31" Type="http://schemas.openxmlformats.org/officeDocument/2006/relationships/image" Target="../media/image36.png"/><Relationship Id="rId4" Type="http://schemas.openxmlformats.org/officeDocument/2006/relationships/image" Target="../media/image20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25.emf"/><Relationship Id="rId22" Type="http://schemas.openxmlformats.org/officeDocument/2006/relationships/image" Target="../media/image29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3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oleObject" Target="../embeddings/oleObject16.bin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5" Type="http://schemas.openxmlformats.org/officeDocument/2006/relationships/image" Target="../media/image50.png"/><Relationship Id="rId10" Type="http://schemas.openxmlformats.org/officeDocument/2006/relationships/image" Target="../media/image45.png"/><Relationship Id="rId4" Type="http://schemas.openxmlformats.org/officeDocument/2006/relationships/image" Target="../media/image39.emf"/><Relationship Id="rId9" Type="http://schemas.openxmlformats.org/officeDocument/2006/relationships/image" Target="../media/image44.png"/><Relationship Id="rId14" Type="http://schemas.openxmlformats.org/officeDocument/2006/relationships/image" Target="../media/image4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14C1920-3638-B94C-564A-47F987ACB30B}"/>
              </a:ext>
            </a:extLst>
          </p:cNvPr>
          <p:cNvSpPr txBox="1"/>
          <p:nvPr/>
        </p:nvSpPr>
        <p:spPr>
          <a:xfrm>
            <a:off x="4196914" y="9536668"/>
            <a:ext cx="2775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8832D5FF-4AFC-BD22-0AF5-5745554E2BEE}"/>
              </a:ext>
            </a:extLst>
          </p:cNvPr>
          <p:cNvGrpSpPr/>
          <p:nvPr/>
        </p:nvGrpSpPr>
        <p:grpSpPr>
          <a:xfrm>
            <a:off x="264236" y="1792645"/>
            <a:ext cx="5804612" cy="2197598"/>
            <a:chOff x="455502" y="2678202"/>
            <a:chExt cx="5804612" cy="2197598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ED9CBAE-1EE8-1AF7-D798-091C170228AE}"/>
                </a:ext>
              </a:extLst>
            </p:cNvPr>
            <p:cNvSpPr txBox="1"/>
            <p:nvPr/>
          </p:nvSpPr>
          <p:spPr>
            <a:xfrm>
              <a:off x="2993618" y="2678202"/>
              <a:ext cx="356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 err="1"/>
                <a:t>iLN</a:t>
              </a:r>
              <a:endParaRPr lang="en-GB" sz="1000" b="1" dirty="0"/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8CA228F6-EDA3-FC90-7643-98BF5482E073}"/>
                </a:ext>
              </a:extLst>
            </p:cNvPr>
            <p:cNvCxnSpPr>
              <a:cxnSpLocks/>
            </p:cNvCxnSpPr>
            <p:nvPr/>
          </p:nvCxnSpPr>
          <p:spPr>
            <a:xfrm>
              <a:off x="785433" y="2887044"/>
              <a:ext cx="50188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F0E1109-D4B2-D47C-F1A3-5E22629A33AC}"/>
                </a:ext>
              </a:extLst>
            </p:cNvPr>
            <p:cNvSpPr txBox="1"/>
            <p:nvPr/>
          </p:nvSpPr>
          <p:spPr>
            <a:xfrm>
              <a:off x="2631249" y="2878411"/>
              <a:ext cx="6142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+</a:t>
              </a:r>
              <a:endParaRPr lang="en-GB" sz="1200" i="1" baseline="300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4B7D05A-5A3E-2417-AE9B-6D154E521C6C}"/>
                </a:ext>
              </a:extLst>
            </p:cNvPr>
            <p:cNvSpPr txBox="1"/>
            <p:nvPr/>
          </p:nvSpPr>
          <p:spPr>
            <a:xfrm>
              <a:off x="3421698" y="2878411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-</a:t>
              </a:r>
              <a:endParaRPr lang="en-GB" sz="1200" i="1" baseline="30000" dirty="0"/>
            </a:p>
          </p:txBody>
        </p:sp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588D2BE6-613B-18E2-DB06-4B05B035101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93288234"/>
                </p:ext>
              </p:extLst>
            </p:nvPr>
          </p:nvGraphicFramePr>
          <p:xfrm>
            <a:off x="4243989" y="3198333"/>
            <a:ext cx="2016125" cy="1366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244463" imgH="2202408" progId="Prism9.Document">
                    <p:embed/>
                  </p:oleObj>
                </mc:Choice>
                <mc:Fallback>
                  <p:oleObj name="Prism 9" r:id="rId3" imgW="3244463" imgH="2202408" progId="Prism9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588D2BE6-613B-18E2-DB06-4B05B035101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43989" y="3198333"/>
                          <a:ext cx="2016125" cy="13668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1E1E68C9-1FAA-D976-B257-ABA495AF5EC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07914" y="3040105"/>
              <a:ext cx="794957" cy="767715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D6C5E091-F9EA-8033-7BD7-2BCF7B0911E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07914" y="3916654"/>
              <a:ext cx="794957" cy="770192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1D713C22-68E7-CF53-D4C6-C4268CA85D5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8263" y="3040105"/>
              <a:ext cx="794957" cy="767715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F782F54-61D6-CB26-C04C-6685C2B21EA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18263" y="3914178"/>
              <a:ext cx="794957" cy="772668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96B5A73-2952-0BAC-9AA8-5AE22C124A87}"/>
                </a:ext>
              </a:extLst>
            </p:cNvPr>
            <p:cNvSpPr txBox="1"/>
            <p:nvPr/>
          </p:nvSpPr>
          <p:spPr>
            <a:xfrm>
              <a:off x="913188" y="2878411"/>
              <a:ext cx="319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err="1"/>
                <a:t>wt</a:t>
              </a:r>
              <a:endParaRPr lang="en-GB" sz="1200" baseline="300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5AB5219-FF77-002A-8B7A-287771AB9C85}"/>
                </a:ext>
              </a:extLst>
            </p:cNvPr>
            <p:cNvSpPr txBox="1"/>
            <p:nvPr/>
          </p:nvSpPr>
          <p:spPr>
            <a:xfrm>
              <a:off x="1646010" y="2878411"/>
              <a:ext cx="4171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bmb</a:t>
              </a:r>
              <a:endParaRPr lang="en-GB" sz="1200" i="1" baseline="30000" dirty="0"/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C879FD7F-9901-72EA-52AD-9C9AE6CF37B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67099" y="3037628"/>
              <a:ext cx="794957" cy="770192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8A9581A7-4163-BA25-6DFD-50EC473005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467099" y="3914178"/>
              <a:ext cx="794957" cy="772668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B85FDB55-F5A5-BDD2-76F5-192DB69475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256750" y="3037628"/>
              <a:ext cx="794957" cy="770192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E54010A5-CA8B-97E3-FE2A-E63AB39FB2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56750" y="3914178"/>
              <a:ext cx="794957" cy="772668"/>
            </a:xfrm>
            <a:prstGeom prst="rect">
              <a:avLst/>
            </a:prstGeom>
          </p:spPr>
        </p:pic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EDC507D2-06BB-59C5-2681-7502ED1AAF45}"/>
                </a:ext>
              </a:extLst>
            </p:cNvPr>
            <p:cNvGrpSpPr/>
            <p:nvPr/>
          </p:nvGrpSpPr>
          <p:grpSpPr>
            <a:xfrm>
              <a:off x="455502" y="3099070"/>
              <a:ext cx="3568313" cy="1776730"/>
              <a:chOff x="454560" y="2081431"/>
              <a:chExt cx="3568313" cy="1776730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8CC976F-DCFA-8C8B-2113-3D4ADDAF3033}"/>
                  </a:ext>
                </a:extLst>
              </p:cNvPr>
              <p:cNvSpPr txBox="1"/>
              <p:nvPr/>
            </p:nvSpPr>
            <p:spPr>
              <a:xfrm>
                <a:off x="680814" y="3611940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FoxP3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AF3EC53-B155-6C74-1CEF-2D3FAD25EBEA}"/>
                  </a:ext>
                </a:extLst>
              </p:cNvPr>
              <p:cNvSpPr txBox="1"/>
              <p:nvPr/>
            </p:nvSpPr>
            <p:spPr>
              <a:xfrm rot="16200000">
                <a:off x="288981" y="3275351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CD25</a:t>
                </a:r>
              </a:p>
            </p:txBody>
          </p: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16EB251C-C8A2-1BA2-3C0B-94656E9B318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71361" y="2081431"/>
                <a:ext cx="0" cy="115393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859B99CF-F57F-8393-53A7-5CE6AB691780}"/>
                  </a:ext>
                </a:extLst>
              </p:cNvPr>
              <p:cNvSpPr txBox="1"/>
              <p:nvPr/>
            </p:nvSpPr>
            <p:spPr>
              <a:xfrm>
                <a:off x="680814" y="2730277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GITR</a:t>
                </a: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1BE5DC8A-1535-4B79-0CE3-8C122DDB3C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6873" y="2853387"/>
                <a:ext cx="2916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>
                <a:extLst>
                  <a:ext uri="{FF2B5EF4-FFF2-40B4-BE49-F238E27FC236}">
                    <a16:creationId xmlns:a16="http://schemas.microsoft.com/office/drawing/2014/main" id="{E9390835-433F-DE06-0E1F-A79469A3BA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73" y="3735145"/>
                <a:ext cx="2844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F0CDE1D5-C3C5-BA5E-5614-AE23214C6460}"/>
              </a:ext>
            </a:extLst>
          </p:cNvPr>
          <p:cNvGrpSpPr/>
          <p:nvPr/>
        </p:nvGrpSpPr>
        <p:grpSpPr>
          <a:xfrm>
            <a:off x="264236" y="4120880"/>
            <a:ext cx="5812734" cy="2190204"/>
            <a:chOff x="461642" y="7700120"/>
            <a:chExt cx="5812734" cy="2190204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43E1AFC-2051-B055-3045-3DD3F14E8228}"/>
                </a:ext>
              </a:extLst>
            </p:cNvPr>
            <p:cNvSpPr txBox="1"/>
            <p:nvPr/>
          </p:nvSpPr>
          <p:spPr>
            <a:xfrm>
              <a:off x="2864577" y="7700120"/>
              <a:ext cx="6142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thymus</a:t>
              </a:r>
            </a:p>
          </p:txBody>
        </p: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08FD9F79-5598-CCB1-25A6-019172116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18263" y="8054866"/>
              <a:ext cx="794957" cy="777621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622D4A99-2026-249A-E340-B88D3AB29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18263" y="8931309"/>
              <a:ext cx="794957" cy="775145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0D37A6DA-3C9F-401D-EE9B-0D6C68F481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407914" y="8059819"/>
              <a:ext cx="794957" cy="772668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F7587F55-EC88-7DC1-EEFD-7E7375B674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407914" y="8931309"/>
              <a:ext cx="794957" cy="775145"/>
            </a:xfrm>
            <a:prstGeom prst="rect">
              <a:avLst/>
            </a:prstGeom>
          </p:spPr>
        </p:pic>
        <p:graphicFrame>
          <p:nvGraphicFramePr>
            <p:cNvPr id="56" name="Object 55">
              <a:extLst>
                <a:ext uri="{FF2B5EF4-FFF2-40B4-BE49-F238E27FC236}">
                  <a16:creationId xmlns:a16="http://schemas.microsoft.com/office/drawing/2014/main" id="{AF7044C8-CA27-12F4-E43C-16A98AA53CE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96904601"/>
                </p:ext>
              </p:extLst>
            </p:nvPr>
          </p:nvGraphicFramePr>
          <p:xfrm>
            <a:off x="4234705" y="8199260"/>
            <a:ext cx="2039671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3282277" imgH="2202408" progId="Prism9.Document">
                    <p:embed/>
                  </p:oleObj>
                </mc:Choice>
                <mc:Fallback>
                  <p:oleObj name="Prism 9" r:id="rId17" imgW="3282277" imgH="2202408" progId="Prism9.Document">
                    <p:embed/>
                    <p:pic>
                      <p:nvPicPr>
                        <p:cNvPr id="56" name="Object 55">
                          <a:extLst>
                            <a:ext uri="{FF2B5EF4-FFF2-40B4-BE49-F238E27FC236}">
                              <a16:creationId xmlns:a16="http://schemas.microsoft.com/office/drawing/2014/main" id="{AF7044C8-CA27-12F4-E43C-16A98AA53CE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4234705" y="8199260"/>
                          <a:ext cx="2039671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EA5A93CE-DDF1-DB3E-3133-07C7D77A58DD}"/>
                </a:ext>
              </a:extLst>
            </p:cNvPr>
            <p:cNvCxnSpPr>
              <a:cxnSpLocks/>
            </p:cNvCxnSpPr>
            <p:nvPr/>
          </p:nvCxnSpPr>
          <p:spPr>
            <a:xfrm>
              <a:off x="792515" y="7909084"/>
              <a:ext cx="50188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5CE6029-7533-819C-A4FA-87F4FC9E94E4}"/>
                </a:ext>
              </a:extLst>
            </p:cNvPr>
            <p:cNvSpPr txBox="1"/>
            <p:nvPr/>
          </p:nvSpPr>
          <p:spPr>
            <a:xfrm>
              <a:off x="2638331" y="7900451"/>
              <a:ext cx="6142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+</a:t>
              </a:r>
              <a:endParaRPr lang="en-GB" sz="1200" i="1" baseline="300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1A6DA4C-EA8E-BC66-1D88-4FFB3E36F2BF}"/>
                </a:ext>
              </a:extLst>
            </p:cNvPr>
            <p:cNvSpPr txBox="1"/>
            <p:nvPr/>
          </p:nvSpPr>
          <p:spPr>
            <a:xfrm>
              <a:off x="3428780" y="7900451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-</a:t>
              </a:r>
              <a:endParaRPr lang="en-GB" sz="1200" i="1" baseline="3000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430D3DB-8C54-ADE2-28B1-21108C32C2C4}"/>
                </a:ext>
              </a:extLst>
            </p:cNvPr>
            <p:cNvSpPr txBox="1"/>
            <p:nvPr/>
          </p:nvSpPr>
          <p:spPr>
            <a:xfrm>
              <a:off x="920270" y="7900451"/>
              <a:ext cx="319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err="1"/>
                <a:t>wt</a:t>
              </a:r>
              <a:endParaRPr lang="en-GB" sz="1200" baseline="300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66D71A5C-9218-7A78-007A-2B1DF97CFB3B}"/>
                </a:ext>
              </a:extLst>
            </p:cNvPr>
            <p:cNvSpPr txBox="1"/>
            <p:nvPr/>
          </p:nvSpPr>
          <p:spPr>
            <a:xfrm>
              <a:off x="1653092" y="7900451"/>
              <a:ext cx="4171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bmb</a:t>
              </a:r>
              <a:endParaRPr lang="en-GB" sz="1200" i="1" baseline="30000" dirty="0"/>
            </a:p>
          </p:txBody>
        </p: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CDCEAE6C-0018-0C19-860C-C2AC7EE18E4F}"/>
                </a:ext>
              </a:extLst>
            </p:cNvPr>
            <p:cNvGrpSpPr/>
            <p:nvPr/>
          </p:nvGrpSpPr>
          <p:grpSpPr>
            <a:xfrm>
              <a:off x="461642" y="8113594"/>
              <a:ext cx="3568313" cy="1776730"/>
              <a:chOff x="454560" y="2081431"/>
              <a:chExt cx="3568313" cy="1776730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0D63ED4C-C5EE-1D63-BC65-54C58710A74A}"/>
                  </a:ext>
                </a:extLst>
              </p:cNvPr>
              <p:cNvSpPr txBox="1"/>
              <p:nvPr/>
            </p:nvSpPr>
            <p:spPr>
              <a:xfrm>
                <a:off x="680814" y="3611940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FoxP3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8893EC7-4FE7-BD06-23E2-7065BAB0BF91}"/>
                  </a:ext>
                </a:extLst>
              </p:cNvPr>
              <p:cNvSpPr txBox="1"/>
              <p:nvPr/>
            </p:nvSpPr>
            <p:spPr>
              <a:xfrm rot="16200000">
                <a:off x="288981" y="3275351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CD25</a:t>
                </a:r>
              </a:p>
            </p:txBody>
          </p: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92C26CFA-B2A8-71DE-0460-06A0887337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71361" y="2081431"/>
                <a:ext cx="0" cy="115393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9BF62ECD-0D9D-ADD0-1D22-40044CBB1377}"/>
                  </a:ext>
                </a:extLst>
              </p:cNvPr>
              <p:cNvSpPr txBox="1"/>
              <p:nvPr/>
            </p:nvSpPr>
            <p:spPr>
              <a:xfrm>
                <a:off x="680814" y="2730277"/>
                <a:ext cx="5773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GITR</a:t>
                </a:r>
              </a:p>
            </p:txBody>
          </p: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id="{3F17C26D-DF0F-E096-DDBF-C1F31E9840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6873" y="2853387"/>
                <a:ext cx="2916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id="{CF8BE821-0EB5-D069-9E1A-66DFDA34A3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73" y="3735145"/>
                <a:ext cx="2844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0615FD75-13C8-7065-3280-28DF3F49FA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67099" y="8062295"/>
              <a:ext cx="794957" cy="770192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710AA8BA-D3AE-2557-F615-84FA774B27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467099" y="8936262"/>
              <a:ext cx="794957" cy="770192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7EDA076A-4E48-015F-D635-CF2C8D4C6B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256750" y="8057342"/>
              <a:ext cx="794957" cy="775145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3C8F693A-10FE-8C2D-7516-9BC1F1350A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256750" y="8933786"/>
              <a:ext cx="794957" cy="772668"/>
            </a:xfrm>
            <a:prstGeom prst="rect">
              <a:avLst/>
            </a:prstGeom>
          </p:spPr>
        </p:pic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6C5A59DC-BF6F-EE35-598A-3111093AAB5A}"/>
              </a:ext>
            </a:extLst>
          </p:cNvPr>
          <p:cNvSpPr txBox="1"/>
          <p:nvPr/>
        </p:nvSpPr>
        <p:spPr>
          <a:xfrm>
            <a:off x="44304" y="6826201"/>
            <a:ext cx="681369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Intact T cell compartments in the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i="1" baseline="30000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onditional knock-out mice. Representative flow cytometry plots showing gating strategy for CD2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GITR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FoxP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gs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left FACS panels) and their frequencies (right graph bars) in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iLN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 thymus. Data is representative of three experiments with 5-6 mice per group. Numbers adjacent to gates indicate cell frequencies in the parent population. Bars and error bars represent mean ± SD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ces between groups were analyzed by a Mann-Whitney test (GraphPad Prism v8). Statistical significance is indicated with ns, not significant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gt;0.05 and **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≤0.01.</a:t>
            </a:r>
            <a:endParaRPr lang="sv-SE" sz="12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470B634-CC87-B87E-A1FB-8007375575B3}"/>
              </a:ext>
            </a:extLst>
          </p:cNvPr>
          <p:cNvSpPr txBox="1"/>
          <p:nvPr/>
        </p:nvSpPr>
        <p:spPr>
          <a:xfrm>
            <a:off x="1607986" y="867781"/>
            <a:ext cx="34891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Material</a:t>
            </a:r>
            <a:endParaRPr lang="sv-SE" sz="1800" b="1" i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CFBB1840-31C4-C12B-252F-EE236F140744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383" y="162801"/>
            <a:ext cx="1382395" cy="4965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41141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F9F119F-7BF0-4687-AD91-A6A951363A69}"/>
              </a:ext>
            </a:extLst>
          </p:cNvPr>
          <p:cNvSpPr txBox="1"/>
          <p:nvPr/>
        </p:nvSpPr>
        <p:spPr>
          <a:xfrm>
            <a:off x="4196914" y="9536668"/>
            <a:ext cx="2775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4A39353-BE67-4B1D-BEE6-E472CD97AF44}"/>
              </a:ext>
            </a:extLst>
          </p:cNvPr>
          <p:cNvSpPr txBox="1"/>
          <p:nvPr/>
        </p:nvSpPr>
        <p:spPr>
          <a:xfrm>
            <a:off x="44304" y="6996136"/>
            <a:ext cx="676939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2. (A)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Natural/steady-state serum levels of IgG1, IgG2b, IgG2c, IgG3, and IgA. Bars and error bars indicate mean ± SD. Data are representative of two experiments with 3-5 mice per group.</a:t>
            </a:r>
            <a:r>
              <a:rPr lang="en-US" sz="1200" dirty="0"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flow cytometry plots showing gating strategy for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arginal zone (MZB) and follicular B cell (FOB)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tainings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rom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umbl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mb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and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ice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opulations shown are pre-gated as B220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D93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mature) B cells. 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umbers adjacent to gates indicate cell frequencies in the parent gate. Bar graph shows frequencies of MZB cells in the parent population. Bars and error bars represent mean ± SD. Data are representative of three experiment with 3-8 mice per group.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C)</a:t>
            </a:r>
            <a:r>
              <a:rPr lang="sv-SE" sz="1200" b="1" dirty="0"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histograms show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on B220</a:t>
            </a:r>
            <a:r>
              <a:rPr lang="sv-SE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lenic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 cells from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ed), </a:t>
            </a:r>
            <a:r>
              <a:rPr lang="sv-SE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umble</a:t>
            </a:r>
            <a:r>
              <a:rPr lang="sv-SE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mb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reen)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Bar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 MFI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n B220</a:t>
            </a:r>
            <a:r>
              <a:rPr lang="sv-SE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 cells. Data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ependent experiments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-7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Bars and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ror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rs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sv-S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± SD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ces between groups were analyzed by a Mann-Whitney test (GraphPad Prism v8). Statistical significance is indicated with ns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gt;0.05 and *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≤0.05.</a:t>
            </a:r>
            <a:endParaRPr lang="sv-S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D7971C9D-25BC-04BE-772B-A06B4EED107A}"/>
              </a:ext>
            </a:extLst>
          </p:cNvPr>
          <p:cNvGrpSpPr/>
          <p:nvPr/>
        </p:nvGrpSpPr>
        <p:grpSpPr>
          <a:xfrm>
            <a:off x="114596" y="187762"/>
            <a:ext cx="6628807" cy="3603625"/>
            <a:chOff x="141881" y="273050"/>
            <a:chExt cx="6628807" cy="3603625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7FA8C979-B1C2-4CF0-B59C-C53E7C3EB76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7285695"/>
                </p:ext>
              </p:extLst>
            </p:nvPr>
          </p:nvGraphicFramePr>
          <p:xfrm>
            <a:off x="141881" y="273641"/>
            <a:ext cx="1484284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224198" imgH="2696393" progId="Prism9.Document">
                    <p:embed/>
                  </p:oleObj>
                </mc:Choice>
                <mc:Fallback>
                  <p:oleObj name="Prism 9" r:id="rId3" imgW="2224198" imgH="2696393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7FA8C979-B1C2-4CF0-B59C-C53E7C3EB76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41881" y="273641"/>
                          <a:ext cx="1484284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6A3C5180-D3C5-432B-9F86-1E7F732D444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80433114"/>
                </p:ext>
              </p:extLst>
            </p:nvPr>
          </p:nvGraphicFramePr>
          <p:xfrm>
            <a:off x="1393825" y="273050"/>
            <a:ext cx="1482725" cy="1801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221317" imgH="2696393" progId="Prism9.Document">
                    <p:embed/>
                  </p:oleObj>
                </mc:Choice>
                <mc:Fallback>
                  <p:oleObj name="Prism 9" r:id="rId5" imgW="2221317" imgH="2696393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6A3C5180-D3C5-432B-9F86-1E7F732D444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93825" y="273050"/>
                          <a:ext cx="1482725" cy="1801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7363FE87-AB1C-4873-ABD1-207A45DC72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31632348"/>
                </p:ext>
              </p:extLst>
            </p:nvPr>
          </p:nvGraphicFramePr>
          <p:xfrm>
            <a:off x="3886292" y="273416"/>
            <a:ext cx="1484313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2224198" imgH="2696393" progId="Prism9.Document">
                    <p:embed/>
                  </p:oleObj>
                </mc:Choice>
                <mc:Fallback>
                  <p:oleObj name="Prism 9" r:id="rId7" imgW="2224198" imgH="2696393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7363FE87-AB1C-4873-ABD1-207A45DC72A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886292" y="273416"/>
                          <a:ext cx="1484313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2C1E5332-B393-404A-9FC8-A041EDE99D0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028718"/>
                </p:ext>
              </p:extLst>
            </p:nvPr>
          </p:nvGraphicFramePr>
          <p:xfrm>
            <a:off x="5138738" y="273416"/>
            <a:ext cx="1631950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484936" imgH="2740679" progId="Prism9.Document">
                    <p:embed/>
                  </p:oleObj>
                </mc:Choice>
                <mc:Fallback>
                  <p:oleObj name="Prism 9" r:id="rId9" imgW="2484936" imgH="2740679" progId="Prism9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2C1E5332-B393-404A-9FC8-A041EDE99D0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138738" y="273416"/>
                          <a:ext cx="1631950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EDA13DF9-AA2A-4829-A279-8D706A765B6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45367537"/>
                </p:ext>
              </p:extLst>
            </p:nvPr>
          </p:nvGraphicFramePr>
          <p:xfrm>
            <a:off x="1544638" y="2076450"/>
            <a:ext cx="1089025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1785193" imgH="2955267" progId="Prism9.Document">
                    <p:embed/>
                  </p:oleObj>
                </mc:Choice>
                <mc:Fallback>
                  <p:oleObj name="Prism 9" r:id="rId11" imgW="1785193" imgH="2955267" progId="Prism9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EDA13DF9-AA2A-4829-A279-8D706A765B6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544638" y="2076450"/>
                          <a:ext cx="1089025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1474C3A7-8C36-42A6-9FDD-8730C9C05AF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3371091"/>
                </p:ext>
              </p:extLst>
            </p:nvPr>
          </p:nvGraphicFramePr>
          <p:xfrm>
            <a:off x="5354638" y="2076450"/>
            <a:ext cx="1087437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1788434" imgH="2955267" progId="Prism9.Document">
                    <p:embed/>
                  </p:oleObj>
                </mc:Choice>
                <mc:Fallback>
                  <p:oleObj name="Prism 9" r:id="rId13" imgW="1788434" imgH="2955267" progId="Prism9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1474C3A7-8C36-42A6-9FDD-8730C9C05A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354638" y="2076450"/>
                          <a:ext cx="1087437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3E8D5442-9EBD-452A-87A4-A7520EC9549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11329464"/>
                </p:ext>
              </p:extLst>
            </p:nvPr>
          </p:nvGraphicFramePr>
          <p:xfrm>
            <a:off x="2644775" y="273050"/>
            <a:ext cx="1473200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242565" imgH="2740679" progId="Prism9.Document">
                    <p:embed/>
                  </p:oleObj>
                </mc:Choice>
                <mc:Fallback>
                  <p:oleObj name="Prism 9" r:id="rId15" imgW="2242565" imgH="2740679" progId="Prism9.Document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id="{3E8D5442-9EBD-452A-87A4-A7520EC9549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644775" y="273050"/>
                          <a:ext cx="1473200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BBD17903-1E78-4CD4-8E99-CC079E62056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25773067"/>
                </p:ext>
              </p:extLst>
            </p:nvPr>
          </p:nvGraphicFramePr>
          <p:xfrm>
            <a:off x="2814638" y="2076450"/>
            <a:ext cx="1087437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1788434" imgH="2955267" progId="Prism9.Document">
                    <p:embed/>
                  </p:oleObj>
                </mc:Choice>
                <mc:Fallback>
                  <p:oleObj name="Prism 9" r:id="rId17" imgW="1788434" imgH="2955267" progId="Prism9.Document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BBD17903-1E78-4CD4-8E99-CC079E62056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814638" y="2076450"/>
                          <a:ext cx="1087437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0C655802-38A9-6783-0C5C-A64496FF72E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660790"/>
                </p:ext>
              </p:extLst>
            </p:nvPr>
          </p:nvGraphicFramePr>
          <p:xfrm>
            <a:off x="260350" y="2076450"/>
            <a:ext cx="1090613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1789874" imgH="2955267" progId="Prism9.Document">
                    <p:embed/>
                  </p:oleObj>
                </mc:Choice>
                <mc:Fallback>
                  <p:oleObj name="Prism 9" r:id="rId19" imgW="1789874" imgH="2955267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0C655802-38A9-6783-0C5C-A64496FF72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60350" y="2076450"/>
                          <a:ext cx="1090613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44EFB3F3-24D1-AC84-A4C5-5F300C8386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28599084"/>
                </p:ext>
              </p:extLst>
            </p:nvPr>
          </p:nvGraphicFramePr>
          <p:xfrm>
            <a:off x="4084638" y="2076450"/>
            <a:ext cx="1089025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1" imgW="1789874" imgH="2955267" progId="Prism9.Document">
                    <p:embed/>
                  </p:oleObj>
                </mc:Choice>
                <mc:Fallback>
                  <p:oleObj name="Prism 9" r:id="rId21" imgW="1789874" imgH="2955267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44EFB3F3-24D1-AC84-A4C5-5F300C83860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4084638" y="2076450"/>
                          <a:ext cx="1089025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85026DFE-80D1-8297-8E24-75D2EEE94A2C}"/>
              </a:ext>
            </a:extLst>
          </p:cNvPr>
          <p:cNvSpPr txBox="1"/>
          <p:nvPr/>
        </p:nvSpPr>
        <p:spPr>
          <a:xfrm>
            <a:off x="-8965" y="228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57748088-6772-5B88-50B9-EB557997AD76}"/>
              </a:ext>
            </a:extLst>
          </p:cNvPr>
          <p:cNvGrpSpPr/>
          <p:nvPr/>
        </p:nvGrpSpPr>
        <p:grpSpPr>
          <a:xfrm>
            <a:off x="-8965" y="3786994"/>
            <a:ext cx="3918625" cy="3043830"/>
            <a:chOff x="-8965" y="3786994"/>
            <a:chExt cx="3918625" cy="304383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518BA72-E217-F334-2911-FB6A4483E30F}"/>
                </a:ext>
              </a:extLst>
            </p:cNvPr>
            <p:cNvSpPr txBox="1"/>
            <p:nvPr/>
          </p:nvSpPr>
          <p:spPr>
            <a:xfrm>
              <a:off x="-8965" y="3786994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10741EBD-F6BF-13D1-0519-046AB02822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84392" y="4369770"/>
              <a:ext cx="936000" cy="93600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F0F80C8B-E1E5-B720-07EA-3EDFAF5639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248377" y="4369770"/>
              <a:ext cx="936000" cy="93600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E321367C-7013-9172-BC21-7DD4D91252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4392" y="5696892"/>
              <a:ext cx="936000" cy="936000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1EE72592-4B2D-F7B8-9A05-53AC89C81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248377" y="5696892"/>
              <a:ext cx="936000" cy="936000"/>
            </a:xfrm>
            <a:prstGeom prst="rect">
              <a:avLst/>
            </a:prstGeom>
          </p:spPr>
        </p:pic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4022B2B3-0AC4-0983-9904-8F4D4F0A243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7450762"/>
                </p:ext>
              </p:extLst>
            </p:nvPr>
          </p:nvGraphicFramePr>
          <p:xfrm>
            <a:off x="2242339" y="4101335"/>
            <a:ext cx="1494318" cy="12782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7" imgW="2576411" imgH="2203849" progId="Prism9.Document">
                    <p:embed/>
                  </p:oleObj>
                </mc:Choice>
                <mc:Fallback>
                  <p:oleObj name="Prism 9" r:id="rId27" imgW="2576411" imgH="2203849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022B2B3-0AC4-0983-9904-8F4D4F0A243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2242339" y="4101335"/>
                          <a:ext cx="1494318" cy="12782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67396F5A-E74A-F180-0D93-230C260544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13525985"/>
                </p:ext>
              </p:extLst>
            </p:nvPr>
          </p:nvGraphicFramePr>
          <p:xfrm>
            <a:off x="2215445" y="5419256"/>
            <a:ext cx="1694215" cy="13030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9" imgW="2921061" imgH="2246694" progId="Prism9.Document">
                    <p:embed/>
                  </p:oleObj>
                </mc:Choice>
                <mc:Fallback>
                  <p:oleObj name="Prism 9" r:id="rId29" imgW="2921061" imgH="2246694" progId="Prism9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67396F5A-E74A-F180-0D93-230C260544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2215445" y="5419256"/>
                          <a:ext cx="1694215" cy="13030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EE62932-BED8-F67B-64C0-DD71C6C541D3}"/>
                </a:ext>
              </a:extLst>
            </p:cNvPr>
            <p:cNvSpPr txBox="1"/>
            <p:nvPr/>
          </p:nvSpPr>
          <p:spPr>
            <a:xfrm>
              <a:off x="258799" y="6584603"/>
              <a:ext cx="5260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CD23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1A110CE0-E7CE-47B5-39A8-2C9F8BE53245}"/>
                </a:ext>
              </a:extLst>
            </p:cNvPr>
            <p:cNvCxnSpPr>
              <a:cxnSpLocks/>
            </p:cNvCxnSpPr>
            <p:nvPr/>
          </p:nvCxnSpPr>
          <p:spPr>
            <a:xfrm>
              <a:off x="661225" y="6707713"/>
              <a:ext cx="1476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6C98C9E-1277-AE99-D4F6-680E4C625DA0}"/>
                </a:ext>
              </a:extLst>
            </p:cNvPr>
            <p:cNvSpPr txBox="1"/>
            <p:nvPr/>
          </p:nvSpPr>
          <p:spPr>
            <a:xfrm>
              <a:off x="606916" y="4178159"/>
              <a:ext cx="290953" cy="224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err="1"/>
                <a:t>wt</a:t>
              </a:r>
              <a:endParaRPr lang="en-GB" sz="10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BB10246-659C-5D14-84BB-602B81B808FB}"/>
                </a:ext>
              </a:extLst>
            </p:cNvPr>
            <p:cNvSpPr txBox="1"/>
            <p:nvPr/>
          </p:nvSpPr>
          <p:spPr>
            <a:xfrm>
              <a:off x="1526352" y="4178159"/>
              <a:ext cx="380051" cy="224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bmb</a:t>
              </a:r>
              <a:endParaRPr lang="en-GB" sz="1000" i="1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9372376-1311-B1B5-D17F-C1D7E752D49E}"/>
                </a:ext>
              </a:extLst>
            </p:cNvPr>
            <p:cNvSpPr txBox="1"/>
            <p:nvPr/>
          </p:nvSpPr>
          <p:spPr>
            <a:xfrm>
              <a:off x="512881" y="5516120"/>
              <a:ext cx="559705" cy="224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+</a:t>
              </a:r>
              <a:endParaRPr lang="en-GB" sz="1200" i="1" baseline="30000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D00D03B-4B04-61CA-A6E7-4BAFB068366A}"/>
                </a:ext>
              </a:extLst>
            </p:cNvPr>
            <p:cNvSpPr txBox="1"/>
            <p:nvPr/>
          </p:nvSpPr>
          <p:spPr>
            <a:xfrm>
              <a:off x="1492913" y="5516120"/>
              <a:ext cx="542178" cy="224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-</a:t>
              </a:r>
              <a:endParaRPr lang="en-GB" sz="1200" i="1" baseline="300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2D1F38E-19E5-2B92-4D40-16D6408D4228}"/>
                </a:ext>
              </a:extLst>
            </p:cNvPr>
            <p:cNvSpPr txBox="1"/>
            <p:nvPr/>
          </p:nvSpPr>
          <p:spPr>
            <a:xfrm rot="16200000">
              <a:off x="-41217" y="6323647"/>
              <a:ext cx="5260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CD21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2588C5C4-C2DE-72E7-3308-35A6C4FA37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733" y="4442175"/>
              <a:ext cx="4191" cy="180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563DE31-D033-AB82-E197-42A97B7E8609}"/>
              </a:ext>
            </a:extLst>
          </p:cNvPr>
          <p:cNvGrpSpPr/>
          <p:nvPr/>
        </p:nvGrpSpPr>
        <p:grpSpPr>
          <a:xfrm>
            <a:off x="3794610" y="3786994"/>
            <a:ext cx="2642116" cy="2934451"/>
            <a:chOff x="3794610" y="3786994"/>
            <a:chExt cx="2642116" cy="2934451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03E503E-B09E-A548-A1F8-D1CDC6373D7E}"/>
                </a:ext>
              </a:extLst>
            </p:cNvPr>
            <p:cNvSpPr txBox="1"/>
            <p:nvPr/>
          </p:nvSpPr>
          <p:spPr>
            <a:xfrm>
              <a:off x="3794610" y="378699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7824333-A103-5C67-713C-4CD6EC25B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4021646" y="4156326"/>
              <a:ext cx="1112505" cy="10800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BFB648A-976C-C93B-5799-B90CA5CAAF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5174154" y="4156326"/>
              <a:ext cx="1112505" cy="108000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5FE7036-8DA2-729A-8939-BFE1066851D1}"/>
                </a:ext>
              </a:extLst>
            </p:cNvPr>
            <p:cNvSpPr txBox="1"/>
            <p:nvPr/>
          </p:nvSpPr>
          <p:spPr>
            <a:xfrm>
              <a:off x="4156573" y="4182056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err="1">
                  <a:solidFill>
                    <a:srgbClr val="FF0000"/>
                  </a:solidFill>
                </a:rPr>
                <a:t>wt</a:t>
              </a:r>
              <a:endParaRPr lang="en-GB" sz="1000" dirty="0">
                <a:solidFill>
                  <a:srgbClr val="FF0000"/>
                </a:solidFill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0E0F1B3-2906-3C99-90AA-EFC4DAFCB4F4}"/>
                </a:ext>
              </a:extLst>
            </p:cNvPr>
            <p:cNvSpPr txBox="1"/>
            <p:nvPr/>
          </p:nvSpPr>
          <p:spPr>
            <a:xfrm>
              <a:off x="4156573" y="4369720"/>
              <a:ext cx="4171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>
                  <a:solidFill>
                    <a:srgbClr val="0000FF"/>
                  </a:solidFill>
                </a:rPr>
                <a:t>bmb</a:t>
              </a:r>
              <a:endParaRPr lang="en-GB" sz="1000" i="1" dirty="0">
                <a:solidFill>
                  <a:srgbClr val="0000FF"/>
                </a:solidFill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810C20B-DA80-2F30-621D-8E04018E13E4}"/>
                </a:ext>
              </a:extLst>
            </p:cNvPr>
            <p:cNvSpPr txBox="1"/>
            <p:nvPr/>
          </p:nvSpPr>
          <p:spPr>
            <a:xfrm>
              <a:off x="5330625" y="4182056"/>
              <a:ext cx="559705" cy="224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+</a:t>
              </a:r>
              <a:endParaRPr lang="en-GB" sz="1200" i="1" baseline="300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9BA9B90-B205-62DB-74C2-E3A445837319}"/>
                </a:ext>
              </a:extLst>
            </p:cNvPr>
            <p:cNvSpPr txBox="1"/>
            <p:nvPr/>
          </p:nvSpPr>
          <p:spPr>
            <a:xfrm>
              <a:off x="5303731" y="4369720"/>
              <a:ext cx="5950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 err="1">
                  <a:solidFill>
                    <a:srgbClr val="00C000"/>
                  </a:solidFill>
                </a:rPr>
                <a:t>nfkbid</a:t>
              </a:r>
              <a:r>
                <a:rPr lang="en-GB" sz="1200" baseline="30000" dirty="0" err="1">
                  <a:solidFill>
                    <a:srgbClr val="00C000"/>
                  </a:solidFill>
                </a:rPr>
                <a:t>B</a:t>
              </a:r>
              <a:r>
                <a:rPr lang="en-GB" sz="1200" baseline="30000" dirty="0">
                  <a:solidFill>
                    <a:srgbClr val="00C000"/>
                  </a:solidFill>
                </a:rPr>
                <a:t>-</a:t>
              </a:r>
              <a:endParaRPr lang="en-GB" sz="1200" i="1" baseline="30000" dirty="0">
                <a:solidFill>
                  <a:srgbClr val="00C000"/>
                </a:solidFill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A042817-7B3D-3F19-D7E1-41F8EB9EB43E}"/>
                </a:ext>
              </a:extLst>
            </p:cNvPr>
            <p:cNvSpPr txBox="1"/>
            <p:nvPr/>
          </p:nvSpPr>
          <p:spPr>
            <a:xfrm>
              <a:off x="4113806" y="5190671"/>
              <a:ext cx="5260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IgM</a:t>
              </a: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2073C0B3-9C39-6214-C71B-B462CAD6FB70}"/>
                </a:ext>
              </a:extLst>
            </p:cNvPr>
            <p:cNvCxnSpPr>
              <a:cxnSpLocks/>
            </p:cNvCxnSpPr>
            <p:nvPr/>
          </p:nvCxnSpPr>
          <p:spPr>
            <a:xfrm>
              <a:off x="4475891" y="5313781"/>
              <a:ext cx="1764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4A0D188D-D345-B7C1-D92B-5756B72DC3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11407643"/>
                </p:ext>
              </p:extLst>
            </p:nvPr>
          </p:nvGraphicFramePr>
          <p:xfrm>
            <a:off x="4150800" y="5400000"/>
            <a:ext cx="2285926" cy="13214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3" imgW="3809876" imgH="2202408" progId="Prism9.Document">
                    <p:embed/>
                  </p:oleObj>
                </mc:Choice>
                <mc:Fallback>
                  <p:oleObj name="Prism 9" r:id="rId33" imgW="3809876" imgH="2202408" progId="Prism9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4A0D188D-D345-B7C1-D92B-5756B72DC3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4150800" y="5400000"/>
                          <a:ext cx="2285926" cy="13214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721888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6BCD03AD-780A-CB07-0768-81B3FBFCCC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4506828"/>
              </p:ext>
            </p:extLst>
          </p:nvPr>
        </p:nvGraphicFramePr>
        <p:xfrm>
          <a:off x="246172" y="4120296"/>
          <a:ext cx="253493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826802" imgH="2717636" progId="Prism9.Document">
                  <p:embed/>
                </p:oleObj>
              </mc:Choice>
              <mc:Fallback>
                <p:oleObj name="Prism 9" r:id="rId3" imgW="3826802" imgH="2717636" progId="Prism9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6BCD03AD-780A-CB07-0768-81B3FBFCCC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6172" y="4120296"/>
                        <a:ext cx="253493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1CE17993-E4E3-1912-C7B5-4CA0E5432A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9544" y="1179891"/>
            <a:ext cx="667276" cy="65604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463B30E-4709-AA73-0328-FC17A5B4AD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9544" y="1838145"/>
            <a:ext cx="667276" cy="65604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A7B8483-CB85-AA31-3286-0A12662A17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9544" y="2496400"/>
            <a:ext cx="667276" cy="6560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D558A69-593A-E734-B295-168498BDDB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9544" y="3154653"/>
            <a:ext cx="667276" cy="6560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98528D0-2DCC-C82D-2FF6-81ED895D63E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66452" y="1179891"/>
            <a:ext cx="667276" cy="65604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85C3457-A497-32C7-E6BA-E23B4CD0B80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66452" y="1838145"/>
            <a:ext cx="667276" cy="65604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673FF7F-D5E0-67F1-3E01-5089C229501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66452" y="2496400"/>
            <a:ext cx="667276" cy="65604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1B738B0-9A60-A78F-24A6-92C3EDB2049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65502" y="3154653"/>
            <a:ext cx="667276" cy="65604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9151A45-E054-9A40-513A-FF9052B4C6A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931751" y="1179891"/>
            <a:ext cx="667276" cy="65604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1B567AC-46F7-FE18-9859-5F9F19DBCA4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31751" y="1838145"/>
            <a:ext cx="667276" cy="65604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80C9AEC-7D8A-BFD8-46BE-BC10AE928B1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31751" y="2496400"/>
            <a:ext cx="667276" cy="65604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57C36EA-FADF-FF8C-4CAF-C6751B2EED1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30801" y="3154653"/>
            <a:ext cx="667276" cy="65604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725CE11-30FA-FCF4-E13A-3A9845128440}"/>
              </a:ext>
            </a:extLst>
          </p:cNvPr>
          <p:cNvSpPr txBox="1"/>
          <p:nvPr/>
        </p:nvSpPr>
        <p:spPr>
          <a:xfrm>
            <a:off x="803119" y="1027033"/>
            <a:ext cx="290953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7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D1B1C5-07DA-23D7-6123-9803B37CBBA9}"/>
              </a:ext>
            </a:extLst>
          </p:cNvPr>
          <p:cNvSpPr txBox="1"/>
          <p:nvPr/>
        </p:nvSpPr>
        <p:spPr>
          <a:xfrm rot="16200000">
            <a:off x="207033" y="1377367"/>
            <a:ext cx="290953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err="1"/>
              <a:t>wt</a:t>
            </a:r>
            <a:endParaRPr lang="en-GB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030CC35-9C48-43CC-AE24-07CF6D97727B}"/>
              </a:ext>
            </a:extLst>
          </p:cNvPr>
          <p:cNvSpPr txBox="1"/>
          <p:nvPr/>
        </p:nvSpPr>
        <p:spPr>
          <a:xfrm rot="16200000">
            <a:off x="162484" y="2026325"/>
            <a:ext cx="380051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i="1" dirty="0" err="1"/>
              <a:t>bmb</a:t>
            </a:r>
            <a:endParaRPr lang="en-GB" sz="1000" i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C64C4D-8250-3588-9F33-D2D1961EAF55}"/>
              </a:ext>
            </a:extLst>
          </p:cNvPr>
          <p:cNvSpPr txBox="1"/>
          <p:nvPr/>
        </p:nvSpPr>
        <p:spPr>
          <a:xfrm rot="16200000">
            <a:off x="72657" y="2675283"/>
            <a:ext cx="559705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i="1" dirty="0" err="1"/>
              <a:t>nfkbid</a:t>
            </a:r>
            <a:r>
              <a:rPr lang="en-GB" sz="1200" baseline="30000" dirty="0" err="1"/>
              <a:t>B</a:t>
            </a:r>
            <a:r>
              <a:rPr lang="en-GB" sz="1200" baseline="30000" dirty="0"/>
              <a:t>+</a:t>
            </a:r>
            <a:endParaRPr lang="en-GB" sz="1200" i="1" baseline="300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B2F881D-4F46-54BC-E3C2-9EFCA55CD3B8}"/>
              </a:ext>
            </a:extLst>
          </p:cNvPr>
          <p:cNvSpPr txBox="1"/>
          <p:nvPr/>
        </p:nvSpPr>
        <p:spPr>
          <a:xfrm rot="16200000">
            <a:off x="81421" y="3324241"/>
            <a:ext cx="542178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i="1" dirty="0" err="1"/>
              <a:t>nfkbid</a:t>
            </a:r>
            <a:r>
              <a:rPr lang="en-GB" sz="1200" baseline="30000" dirty="0" err="1"/>
              <a:t>B</a:t>
            </a:r>
            <a:r>
              <a:rPr lang="en-GB" sz="1200" baseline="30000" dirty="0"/>
              <a:t>-</a:t>
            </a:r>
            <a:endParaRPr lang="en-GB" sz="1200" i="1" baseline="30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FCBB85-FA43-7D61-681A-9C06A98E557C}"/>
              </a:ext>
            </a:extLst>
          </p:cNvPr>
          <p:cNvSpPr txBox="1"/>
          <p:nvPr/>
        </p:nvSpPr>
        <p:spPr>
          <a:xfrm>
            <a:off x="542975" y="3774812"/>
            <a:ext cx="526090" cy="224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D9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B7173B8-0E5D-92EC-B602-D03D3E3E9E77}"/>
              </a:ext>
            </a:extLst>
          </p:cNvPr>
          <p:cNvSpPr txBox="1"/>
          <p:nvPr/>
        </p:nvSpPr>
        <p:spPr>
          <a:xfrm rot="16200000">
            <a:off x="241701" y="3453108"/>
            <a:ext cx="526090" cy="224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GL7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1502394-0E95-94DE-FE28-A0F654CF80D4}"/>
              </a:ext>
            </a:extLst>
          </p:cNvPr>
          <p:cNvCxnSpPr>
            <a:cxnSpLocks/>
          </p:cNvCxnSpPr>
          <p:nvPr/>
        </p:nvCxnSpPr>
        <p:spPr>
          <a:xfrm flipV="1">
            <a:off x="502651" y="216000"/>
            <a:ext cx="4191" cy="324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92DC62E-75EE-B858-610B-6107CA37155C}"/>
              </a:ext>
            </a:extLst>
          </p:cNvPr>
          <p:cNvCxnSpPr>
            <a:cxnSpLocks/>
          </p:cNvCxnSpPr>
          <p:nvPr/>
        </p:nvCxnSpPr>
        <p:spPr>
          <a:xfrm>
            <a:off x="945401" y="3875039"/>
            <a:ext cx="16526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0DFCCA4-15A0-35E7-34B4-0D379951372A}"/>
              </a:ext>
            </a:extLst>
          </p:cNvPr>
          <p:cNvSpPr txBox="1"/>
          <p:nvPr/>
        </p:nvSpPr>
        <p:spPr>
          <a:xfrm>
            <a:off x="1451901" y="1027033"/>
            <a:ext cx="350838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14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5DBD7AA-2D7E-074B-5AF4-160045FAE7E1}"/>
              </a:ext>
            </a:extLst>
          </p:cNvPr>
          <p:cNvSpPr txBox="1"/>
          <p:nvPr/>
        </p:nvSpPr>
        <p:spPr>
          <a:xfrm>
            <a:off x="2133676" y="1027033"/>
            <a:ext cx="350838" cy="224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21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A9F2512-652B-407D-70E9-D34F577F7549}"/>
              </a:ext>
            </a:extLst>
          </p:cNvPr>
          <p:cNvSpPr txBox="1"/>
          <p:nvPr/>
        </p:nvSpPr>
        <p:spPr>
          <a:xfrm>
            <a:off x="4196914" y="9536668"/>
            <a:ext cx="2775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2A8DB8A-9447-6451-111F-32703C1400C0}"/>
              </a:ext>
            </a:extLst>
          </p:cNvPr>
          <p:cNvSpPr txBox="1"/>
          <p:nvPr/>
        </p:nvSpPr>
        <p:spPr>
          <a:xfrm>
            <a:off x="0" y="5958050"/>
            <a:ext cx="67497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3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ce were immunized with 25 µg NP-CGG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ddaVax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.c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in each flank (i.e. 50 µg NP-CGG in total per mouse), and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C B cells from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umbl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mb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and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fkbid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ic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evaluated by flow cytometry 7,</a:t>
            </a:r>
            <a:r>
              <a:rPr lang="en-US" sz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 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4, and 21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ost immunization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flow cytometry plots showing gating strategy for GL7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D95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GC B cell. Populations shown are pre-gated as B220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numbers adjacent to gates indicate cell frequencies in the parent gate. </a:t>
            </a:r>
            <a:r>
              <a:rPr lang="en-US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aïve mice were used as controls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ower bar graph shows frequencies of GL7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D95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GC B cells. Bars and error bars represent mean ± SD. Data are representative of one experiment with 3-5 mice per group.</a:t>
            </a:r>
            <a:endParaRPr lang="sv-SE" sz="1200" dirty="0">
              <a:solidFill>
                <a:srgbClr val="000000"/>
              </a:solidFill>
            </a:endParaRP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362DCD09-7D90-F1D2-7B13-5965BE80D6D6}"/>
              </a:ext>
            </a:extLst>
          </p:cNvPr>
          <p:cNvGrpSpPr/>
          <p:nvPr/>
        </p:nvGrpSpPr>
        <p:grpSpPr>
          <a:xfrm>
            <a:off x="1129459" y="4173769"/>
            <a:ext cx="1077826" cy="407231"/>
            <a:chOff x="1129459" y="4173769"/>
            <a:chExt cx="1077826" cy="407231"/>
          </a:xfrm>
        </p:grpSpPr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03EA7253-E475-F56A-978D-965CC7A812F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29459" y="4438936"/>
              <a:ext cx="50400" cy="504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FD9E621D-E93F-9840-25DE-774DD15F43A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84497" y="4443931"/>
              <a:ext cx="49140" cy="50400"/>
            </a:xfrm>
            <a:prstGeom prst="ellipse">
              <a:avLst/>
            </a:prstGeom>
            <a:solidFill>
              <a:srgbClr val="00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46F066A8-DD4A-1740-F00B-56BA0E6A29E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84497" y="4281541"/>
              <a:ext cx="49140" cy="50400"/>
            </a:xfrm>
            <a:prstGeom prst="ellips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13B93714-0562-4CF2-4E99-87E7D5B3105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29459" y="4284932"/>
              <a:ext cx="50400" cy="504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74B87EA-E551-2391-42A4-2D91B6BCF5F2}"/>
                </a:ext>
              </a:extLst>
            </p:cNvPr>
            <p:cNvSpPr txBox="1"/>
            <p:nvPr/>
          </p:nvSpPr>
          <p:spPr>
            <a:xfrm>
              <a:off x="1139839" y="4334779"/>
              <a:ext cx="4171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i="1" dirty="0" err="1"/>
                <a:t>bmb</a:t>
              </a:r>
              <a:endParaRPr lang="en-GB" sz="1000" i="1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062410B-9E33-9A33-2DDD-C0EF6B13E349}"/>
                </a:ext>
              </a:extLst>
            </p:cNvPr>
            <p:cNvSpPr txBox="1"/>
            <p:nvPr/>
          </p:nvSpPr>
          <p:spPr>
            <a:xfrm>
              <a:off x="1139839" y="4173769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err="1"/>
                <a:t>wt</a:t>
              </a:r>
              <a:endParaRPr lang="en-GB" sz="10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88E83B3-2D1F-EB37-5156-04F68D68D375}"/>
                </a:ext>
              </a:extLst>
            </p:cNvPr>
            <p:cNvSpPr txBox="1"/>
            <p:nvPr/>
          </p:nvSpPr>
          <p:spPr>
            <a:xfrm>
              <a:off x="1594877" y="4173769"/>
              <a:ext cx="6124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+</a:t>
              </a:r>
              <a:endParaRPr lang="en-GB" sz="1200" i="1" baseline="300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4C1BA22-87DB-43A9-F379-DA12A7250691}"/>
                </a:ext>
              </a:extLst>
            </p:cNvPr>
            <p:cNvSpPr txBox="1"/>
            <p:nvPr/>
          </p:nvSpPr>
          <p:spPr>
            <a:xfrm>
              <a:off x="1594877" y="4334779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i="1" dirty="0" err="1"/>
                <a:t>nfkbid</a:t>
              </a:r>
              <a:r>
                <a:rPr lang="en-GB" sz="1200" baseline="30000" dirty="0" err="1"/>
                <a:t>B</a:t>
              </a:r>
              <a:r>
                <a:rPr lang="en-GB" sz="1200" baseline="30000" dirty="0"/>
                <a:t>-</a:t>
              </a:r>
              <a:endParaRPr lang="en-GB" sz="1200" i="1" baseline="30000" dirty="0"/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6B37D6F2-BAD4-1CF9-8CF1-BBF1714555D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79544" y="241577"/>
            <a:ext cx="701802" cy="69723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495E08D1-67AD-536B-B812-1E674415113E}"/>
              </a:ext>
            </a:extLst>
          </p:cNvPr>
          <p:cNvSpPr txBox="1"/>
          <p:nvPr/>
        </p:nvSpPr>
        <p:spPr>
          <a:xfrm rot="16200000">
            <a:off x="28025" y="485645"/>
            <a:ext cx="6270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/>
              <a:t>naïve </a:t>
            </a:r>
            <a:r>
              <a:rPr lang="en-GB" sz="1000" dirty="0" err="1"/>
              <a:t>wt</a:t>
            </a:r>
            <a:endParaRPr lang="en-GB" sz="1000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6317EB1-1C1E-A10F-C800-D544F3289216}"/>
              </a:ext>
            </a:extLst>
          </p:cNvPr>
          <p:cNvCxnSpPr/>
          <p:nvPr/>
        </p:nvCxnSpPr>
        <p:spPr>
          <a:xfrm>
            <a:off x="675241" y="1027033"/>
            <a:ext cx="19049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33412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4D5DB7BB-5940-47D1-B02F-C2CF9203DA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0701427"/>
              </p:ext>
            </p:extLst>
          </p:nvPr>
        </p:nvGraphicFramePr>
        <p:xfrm>
          <a:off x="297712" y="603451"/>
          <a:ext cx="6113721" cy="6857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0266">
                  <a:extLst>
                    <a:ext uri="{9D8B030D-6E8A-4147-A177-3AD203B41FA5}">
                      <a16:colId xmlns:a16="http://schemas.microsoft.com/office/drawing/2014/main" val="4203665929"/>
                    </a:ext>
                  </a:extLst>
                </a:gridCol>
                <a:gridCol w="1935248">
                  <a:extLst>
                    <a:ext uri="{9D8B030D-6E8A-4147-A177-3AD203B41FA5}">
                      <a16:colId xmlns:a16="http://schemas.microsoft.com/office/drawing/2014/main" val="3648468545"/>
                    </a:ext>
                  </a:extLst>
                </a:gridCol>
                <a:gridCol w="1282103">
                  <a:extLst>
                    <a:ext uri="{9D8B030D-6E8A-4147-A177-3AD203B41FA5}">
                      <a16:colId xmlns:a16="http://schemas.microsoft.com/office/drawing/2014/main" val="2151158408"/>
                    </a:ext>
                  </a:extLst>
                </a:gridCol>
                <a:gridCol w="1536104">
                  <a:extLst>
                    <a:ext uri="{9D8B030D-6E8A-4147-A177-3AD203B41FA5}">
                      <a16:colId xmlns:a16="http://schemas.microsoft.com/office/drawing/2014/main" val="4043976351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r>
                        <a:rPr lang="sv-SE" sz="1200" b="1" dirty="0" err="1"/>
                        <a:t>antibody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err="1"/>
                        <a:t>fluorochrome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err="1"/>
                        <a:t>clone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err="1"/>
                        <a:t>company</a:t>
                      </a:r>
                      <a:endParaRPr lang="sv-SE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89007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erCP-Cy5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145-2C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77865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acific </a:t>
                      </a:r>
                      <a:r>
                        <a:rPr lang="sv-SE" sz="1200" dirty="0" err="1"/>
                        <a:t>Blue</a:t>
                      </a:r>
                      <a:r>
                        <a:rPr lang="sv-SE" sz="1200" dirty="0"/>
                        <a:t>/ BV7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RM4-5/GK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316246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biotin</a:t>
                      </a:r>
                      <a:r>
                        <a:rPr lang="sv-SE" sz="1200" dirty="0"/>
                        <a:t>/ BV4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53-7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BioLegend</a:t>
                      </a:r>
                      <a:r>
                        <a:rPr lang="sv-SE" sz="1200" dirty="0"/>
                        <a:t>/ 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296149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8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V650/ FIT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53-6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/ </a:t>
                      </a:r>
                      <a:r>
                        <a:rPr lang="sv-SE" sz="1200" dirty="0" err="1"/>
                        <a:t>Invitrogen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5696749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16/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2.4G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145748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FITC/PE/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1D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375702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CD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7G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3543335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CD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B3B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>
                          <a:solidFill>
                            <a:schemeClr val="tx1"/>
                          </a:solidFill>
                        </a:rPr>
                        <a:t>BioLegend</a:t>
                      </a:r>
                      <a:endParaRPr lang="sv-SE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942391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CD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BV6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PC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>
                          <a:solidFill>
                            <a:schemeClr val="tx1"/>
                          </a:solidFill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031375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S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435781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B220/CD45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erCP-Cy5.5/ BV421/</a:t>
                      </a:r>
                      <a:br>
                        <a:rPr lang="sv-SE" sz="1200" dirty="0"/>
                      </a:br>
                      <a:r>
                        <a:rPr lang="sv-SE" sz="1200" dirty="0"/>
                        <a:t>BV786/ AF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RA3-6B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/ </a:t>
                      </a:r>
                      <a:r>
                        <a:rPr lang="sv-SE" sz="1200" dirty="0" err="1"/>
                        <a:t>BioLegen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4762056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V650/ BV4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AA4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/>
                        <a:t>B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6105816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D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Jo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838725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GL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Biotin</a:t>
                      </a:r>
                      <a:r>
                        <a:rPr lang="sv-SE" sz="1200" dirty="0"/>
                        <a:t>/ AF4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GL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eBioscience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234492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PD-1/ CD2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APC/ AF6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29F.1A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BioLegen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430008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CXCR5/ CD1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BV4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L13D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err="1"/>
                        <a:t>BioLegen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93173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GIT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YGITR7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err="1"/>
                        <a:t>BioLegen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845435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 err="1"/>
                        <a:t>IgM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AF6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RMM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err="1"/>
                        <a:t>BioLegend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2215049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Fox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FIT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FJK1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eBioscinece</a:t>
                      </a:r>
                      <a:endParaRPr lang="sv-S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252963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Live/ </a:t>
                      </a:r>
                      <a:r>
                        <a:rPr lang="sv-SE" sz="1200" dirty="0" err="1"/>
                        <a:t>Dead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Aqua/ Far 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Life Technologi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801359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r>
                        <a:rPr lang="sv-SE" sz="1200" dirty="0"/>
                        <a:t>SA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PerCP-Cy5.5</a:t>
                      </a:r>
                      <a:br>
                        <a:rPr lang="sv-SE" sz="1200" dirty="0"/>
                      </a:br>
                      <a:r>
                        <a:rPr lang="sv-SE" sz="1200" dirty="0"/>
                        <a:t>AF488</a:t>
                      </a:r>
                      <a:br>
                        <a:rPr lang="sv-SE" sz="1200" dirty="0"/>
                      </a:br>
                      <a:r>
                        <a:rPr lang="sv-SE" sz="1200" dirty="0"/>
                        <a:t>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err="1"/>
                        <a:t>eBioscience</a:t>
                      </a:r>
                      <a:endParaRPr lang="sv-SE" sz="1200" dirty="0"/>
                    </a:p>
                    <a:p>
                      <a:r>
                        <a:rPr lang="sv-SE" sz="1200" dirty="0"/>
                        <a:t>Life Technologies</a:t>
                      </a:r>
                    </a:p>
                    <a:p>
                      <a:r>
                        <a:rPr lang="sv-SE" sz="1200" dirty="0"/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714997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5E82FBE-C697-4652-82D9-ED557487BCBA}"/>
              </a:ext>
            </a:extLst>
          </p:cNvPr>
          <p:cNvSpPr txBox="1"/>
          <p:nvPr/>
        </p:nvSpPr>
        <p:spPr>
          <a:xfrm>
            <a:off x="1281831" y="9536668"/>
            <a:ext cx="5576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/>
              <a:t>Supplementary Table 1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994AA1D-3138-F69B-AE0D-6A07AAC5463E}"/>
              </a:ext>
            </a:extLst>
          </p:cNvPr>
          <p:cNvSpPr/>
          <p:nvPr/>
        </p:nvSpPr>
        <p:spPr>
          <a:xfrm>
            <a:off x="184787" y="208363"/>
            <a:ext cx="58138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view of antibodies and reagents used for flow cytometry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9698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89</TotalTime>
  <Words>717</Words>
  <Application>Microsoft Office PowerPoint</Application>
  <PresentationFormat>A4 Paper (210x297 mm)</PresentationFormat>
  <Paragraphs>143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Cambria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resta Khoenkhoen</dc:creator>
  <cp:lastModifiedBy>Monika Àdori</cp:lastModifiedBy>
  <cp:revision>283</cp:revision>
  <cp:lastPrinted>2022-08-23T08:43:25Z</cp:lastPrinted>
  <dcterms:created xsi:type="dcterms:W3CDTF">2020-02-11T14:45:34Z</dcterms:created>
  <dcterms:modified xsi:type="dcterms:W3CDTF">2022-10-10T06:07:01Z</dcterms:modified>
</cp:coreProperties>
</file>